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80" d="100"/>
          <a:sy n="80" d="100"/>
        </p:scale>
        <p:origin x="53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27A773-00C2-463E-9AB5-6B860003E2DA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DD3413-F42B-4568-B875-B072EEA25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806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FD2A0665-0C7D-45D4-859A-CC09420360D2}" type="slidenum">
              <a:rPr lang="el-GR" altLang="el-GR" smtClean="0"/>
              <a:pPr>
                <a:defRPr/>
              </a:pPr>
              <a:t>1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1642521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060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68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12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451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029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422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784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463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507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759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180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5C704-C9DA-43DA-A872-304A7CE75385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5B325-8CBC-48A7-BD30-3D1359163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556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21302" y="2113401"/>
            <a:ext cx="238266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tgu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lumina HiSeq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chnology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548083" y="4647351"/>
            <a:ext cx="175267" cy="292111"/>
          </a:xfrm>
          <a:prstGeom prst="rect">
            <a:avLst/>
          </a:prstGeom>
        </p:spPr>
      </p:pic>
      <p:sp>
        <p:nvSpPr>
          <p:cNvPr id="8" name="Down Arrow 7"/>
          <p:cNvSpPr/>
          <p:nvPr/>
        </p:nvSpPr>
        <p:spPr>
          <a:xfrm>
            <a:off x="1500489" y="1783965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21305" y="1039399"/>
            <a:ext cx="2382655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ion of genomic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ater amberjack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Down Arrow 11"/>
          <p:cNvSpPr/>
          <p:nvPr/>
        </p:nvSpPr>
        <p:spPr>
          <a:xfrm>
            <a:off x="1500489" y="2689466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433845" y="3046257"/>
            <a:ext cx="235757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Assembly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611170" y="3046257"/>
            <a:ext cx="235155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 Assembly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2163" y="4660839"/>
            <a:ext cx="261676" cy="261676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5912912" y="4639519"/>
            <a:ext cx="3075816" cy="30777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expression</a:t>
            </a:r>
          </a:p>
        </p:txBody>
      </p:sp>
      <p:sp>
        <p:nvSpPr>
          <p:cNvPr id="26" name="Bent-Up Arrow 25"/>
          <p:cNvSpPr/>
          <p:nvPr/>
        </p:nvSpPr>
        <p:spPr>
          <a:xfrm rot="5400000">
            <a:off x="4277344" y="3812020"/>
            <a:ext cx="515399" cy="2246076"/>
          </a:xfrm>
          <a:prstGeom prst="bentUpArrow">
            <a:avLst>
              <a:gd name="adj1" fmla="val 20640"/>
              <a:gd name="adj2" fmla="val 18729"/>
              <a:gd name="adj3" fmla="val 22742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5912912" y="5011792"/>
            <a:ext cx="3075816" cy="30777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expression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553221" y="2110079"/>
            <a:ext cx="237150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lumina HiSeq technolo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5"/>
          <a:srcRect l="21392" t="19603" r="20881" b="18221"/>
          <a:stretch/>
        </p:blipFill>
        <p:spPr>
          <a:xfrm>
            <a:off x="4316500" y="2368160"/>
            <a:ext cx="573082" cy="456437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862127" y="1518906"/>
            <a:ext cx="141141" cy="235236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7374" y="1510056"/>
            <a:ext cx="194380" cy="194380"/>
          </a:xfrm>
          <a:prstGeom prst="rect">
            <a:avLst/>
          </a:prstGeom>
        </p:spPr>
      </p:pic>
      <p:sp>
        <p:nvSpPr>
          <p:cNvPr id="39" name="Down Arrow 38"/>
          <p:cNvSpPr/>
          <p:nvPr/>
        </p:nvSpPr>
        <p:spPr>
          <a:xfrm>
            <a:off x="5626830" y="1796147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Down Arrow 40"/>
          <p:cNvSpPr/>
          <p:nvPr/>
        </p:nvSpPr>
        <p:spPr>
          <a:xfrm>
            <a:off x="5658082" y="2710122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9" name="Picture 48" descr="dumareli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6893" y="5088615"/>
            <a:ext cx="337302" cy="1359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49" descr="dumareli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5349" y="5038585"/>
            <a:ext cx="396000" cy="271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l="21392" t="19603" r="20881" b="18221"/>
          <a:stretch/>
        </p:blipFill>
        <p:spPr>
          <a:xfrm>
            <a:off x="141755" y="2347203"/>
            <a:ext cx="563875" cy="449104"/>
          </a:xfrm>
          <a:prstGeom prst="rect">
            <a:avLst/>
          </a:prstGeom>
        </p:spPr>
      </p:pic>
      <p:sp>
        <p:nvSpPr>
          <p:cNvPr id="52" name="Rectangle 51"/>
          <p:cNvSpPr/>
          <p:nvPr/>
        </p:nvSpPr>
        <p:spPr>
          <a:xfrm>
            <a:off x="141755" y="274270"/>
            <a:ext cx="1425390" cy="31745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63" b="1" dirty="0" smtClean="0"/>
              <a:t>Additional </a:t>
            </a:r>
            <a:r>
              <a:rPr lang="en-US" sz="1463" b="1" smtClean="0"/>
              <a:t>file </a:t>
            </a:r>
            <a:r>
              <a:rPr lang="en-US" sz="1463" b="1" smtClean="0"/>
              <a:t>9</a:t>
            </a:r>
            <a:endParaRPr lang="en-US" sz="1463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7415616" y="1035232"/>
            <a:ext cx="1998180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ion of RNA of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 from fast/normal 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ow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ing 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s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Down Arrow 44"/>
          <p:cNvSpPr/>
          <p:nvPr/>
        </p:nvSpPr>
        <p:spPr>
          <a:xfrm>
            <a:off x="8302562" y="2049139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Down Arrow 45"/>
          <p:cNvSpPr/>
          <p:nvPr/>
        </p:nvSpPr>
        <p:spPr>
          <a:xfrm>
            <a:off x="6193845" y="2905707"/>
            <a:ext cx="194057" cy="163156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7" name="Picture 46" descr="dumareli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0400" y="1768992"/>
            <a:ext cx="337302" cy="1359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47" descr="dumareli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5380" y="1483919"/>
            <a:ext cx="396000" cy="28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Group 1"/>
          <p:cNvGrpSpPr/>
          <p:nvPr/>
        </p:nvGrpSpPr>
        <p:grpSpPr>
          <a:xfrm>
            <a:off x="461839" y="1518862"/>
            <a:ext cx="375894" cy="244086"/>
            <a:chOff x="4779774" y="1662456"/>
            <a:chExt cx="375894" cy="244086"/>
          </a:xfrm>
        </p:grpSpPr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5014527" y="1671306"/>
              <a:ext cx="141141" cy="235236"/>
            </a:xfrm>
            <a:prstGeom prst="rect">
              <a:avLst/>
            </a:prstGeom>
          </p:spPr>
        </p:pic>
        <p:pic>
          <p:nvPicPr>
            <p:cNvPr id="55" name="Picture 5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9774" y="1662456"/>
              <a:ext cx="194380" cy="194380"/>
            </a:xfrm>
            <a:prstGeom prst="rect">
              <a:avLst/>
            </a:prstGeom>
          </p:spPr>
        </p:pic>
      </p:grpSp>
      <p:sp>
        <p:nvSpPr>
          <p:cNvPr id="56" name="TextBox 55"/>
          <p:cNvSpPr txBox="1"/>
          <p:nvPr/>
        </p:nvSpPr>
        <p:spPr>
          <a:xfrm>
            <a:off x="4547646" y="1039399"/>
            <a:ext cx="2382655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ion of RNA of 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and male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nads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271228" y="4271595"/>
            <a:ext cx="384738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transcriptom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Down Arrow 57"/>
          <p:cNvSpPr/>
          <p:nvPr/>
        </p:nvSpPr>
        <p:spPr>
          <a:xfrm>
            <a:off x="1501301" y="3552082"/>
            <a:ext cx="223475" cy="44050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Down Arrow 58"/>
          <p:cNvSpPr/>
          <p:nvPr/>
        </p:nvSpPr>
        <p:spPr>
          <a:xfrm>
            <a:off x="4627374" y="3549838"/>
            <a:ext cx="200375" cy="4405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/>
          <p:cNvSpPr txBox="1"/>
          <p:nvPr/>
        </p:nvSpPr>
        <p:spPr>
          <a:xfrm>
            <a:off x="7255380" y="2360688"/>
            <a:ext cx="237150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</a:t>
            </a:r>
          </a:p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lumina MiSeq technolo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AutoShape 2" descr="mage result for MISEQ"/>
          <p:cNvSpPr>
            <a:spLocks noChangeAspect="1" noChangeArrowheads="1"/>
          </p:cNvSpPr>
          <p:nvPr/>
        </p:nvSpPr>
        <p:spPr bwMode="auto">
          <a:xfrm>
            <a:off x="0" y="0"/>
            <a:ext cx="8439150" cy="4552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62" name="Picture 2" descr="mage result for MISEQ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41" t="6420" r="17740" b="11698"/>
          <a:stretch/>
        </p:blipFill>
        <p:spPr bwMode="auto">
          <a:xfrm>
            <a:off x="6989672" y="2691449"/>
            <a:ext cx="432154" cy="2968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Down Arrow 64"/>
          <p:cNvSpPr/>
          <p:nvPr/>
        </p:nvSpPr>
        <p:spPr>
          <a:xfrm>
            <a:off x="8439150" y="2936926"/>
            <a:ext cx="195951" cy="158094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/>
          <p:cNvSpPr txBox="1"/>
          <p:nvPr/>
        </p:nvSpPr>
        <p:spPr>
          <a:xfrm>
            <a:off x="2204969" y="3459880"/>
            <a:ext cx="197167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 annotation MAKER2 pipelin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Down Arrow 41"/>
          <p:cNvSpPr/>
          <p:nvPr/>
        </p:nvSpPr>
        <p:spPr>
          <a:xfrm>
            <a:off x="3094054" y="4082163"/>
            <a:ext cx="224287" cy="25355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02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62</Words>
  <Application>Microsoft Office PowerPoint</Application>
  <PresentationFormat>A4 Paper (210x297 mm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</dc:creator>
  <cp:lastModifiedBy>Elena</cp:lastModifiedBy>
  <cp:revision>18</cp:revision>
  <dcterms:created xsi:type="dcterms:W3CDTF">2017-05-12T12:27:07Z</dcterms:created>
  <dcterms:modified xsi:type="dcterms:W3CDTF">2017-08-09T15:33:31Z</dcterms:modified>
</cp:coreProperties>
</file>